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6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snapVertSplitter="1" vertBarState="minimized" horzBarState="maximized">
    <p:restoredLeft sz="15620"/>
    <p:restoredTop sz="94660"/>
  </p:normalViewPr>
  <p:slideViewPr>
    <p:cSldViewPr>
      <p:cViewPr>
        <p:scale>
          <a:sx n="125" d="100"/>
          <a:sy n="125" d="100"/>
        </p:scale>
        <p:origin x="-869" y="13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0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hyperlink" Target="http://bar.utoronto.ca/cell_efp/cgi-bin/cell_efp.cgi" TargetMode="External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 l="1875" t="10000" r="58125" b="10000"/>
          <a:stretch>
            <a:fillRect/>
          </a:stretch>
        </p:blipFill>
        <p:spPr bwMode="auto">
          <a:xfrm>
            <a:off x="1905000" y="228600"/>
            <a:ext cx="4267200" cy="480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304800" y="5334000"/>
            <a:ext cx="84582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Supplementary Figure 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tree of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terpenoi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terpen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biosynthesis genes from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Salvia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officinalis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ith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selected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terpenoi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terpen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synthase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from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Glycine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 max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plants. The MEGA6 program was used for the alignment of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terpenoi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terpen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genes through neighbor joining method with bootstrap values based on 1000 replicates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28600" y="5562600"/>
            <a:ext cx="8382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ry Figure 2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Heat maps representation the putative transcript levels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erpenoi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genes from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G. max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Expression data for nine tissues (pod, leaves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root_hair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root, nodules, seed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sam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stem and flower) were retrieved from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hytozom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database (phytozome.jgi.doe.gov/). Green/red color-coded heat maps represent relative transcript levels of different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erpenoi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erpen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synthase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genes in G. max, that were determined by alignment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erpenoi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genes protein sequences from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Salvia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officinali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ith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Glycine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max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enomic sequences database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eV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Multi Experiment Viewer software was used to depict transcript levels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 l="8750" t="9136" r="67500" b="87408"/>
          <a:stretch>
            <a:fillRect/>
          </a:stretch>
        </p:blipFill>
        <p:spPr bwMode="auto">
          <a:xfrm>
            <a:off x="1905000" y="838200"/>
            <a:ext cx="28956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2"/>
          <a:srcRect l="8750" t="12600" r="51875" b="31111"/>
          <a:stretch>
            <a:fillRect/>
          </a:stretch>
        </p:blipFill>
        <p:spPr bwMode="auto">
          <a:xfrm>
            <a:off x="1905000" y="1295400"/>
            <a:ext cx="4793751" cy="38547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38"/>
          <p:cNvPicPr>
            <a:picLocks noChangeAspect="1" noChangeArrowheads="1"/>
          </p:cNvPicPr>
          <p:nvPr/>
        </p:nvPicPr>
        <p:blipFill>
          <a:blip r:embed="rId2" cstate="print"/>
          <a:srcRect l="26656" t="68863" r="26685" b="8421"/>
          <a:stretch>
            <a:fillRect/>
          </a:stretch>
        </p:blipFill>
        <p:spPr bwMode="auto">
          <a:xfrm>
            <a:off x="457200" y="533400"/>
            <a:ext cx="7929349" cy="1981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38"/>
          <p:cNvPicPr>
            <a:picLocks noChangeAspect="1" noChangeArrowheads="1"/>
          </p:cNvPicPr>
          <p:nvPr/>
        </p:nvPicPr>
        <p:blipFill>
          <a:blip r:embed="rId2" cstate="print"/>
          <a:srcRect l="42396" t="24110" r="41863" b="53513"/>
          <a:stretch>
            <a:fillRect/>
          </a:stretch>
        </p:blipFill>
        <p:spPr bwMode="auto">
          <a:xfrm>
            <a:off x="3124200" y="2590799"/>
            <a:ext cx="2667000" cy="18288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38"/>
          <p:cNvPicPr>
            <a:picLocks noChangeAspect="1" noChangeArrowheads="1"/>
          </p:cNvPicPr>
          <p:nvPr/>
        </p:nvPicPr>
        <p:blipFill>
          <a:blip r:embed="rId2" cstate="print"/>
          <a:srcRect l="57575" t="46487" r="26685" b="31137"/>
          <a:stretch>
            <a:fillRect/>
          </a:stretch>
        </p:blipFill>
        <p:spPr bwMode="auto">
          <a:xfrm>
            <a:off x="457200" y="2667000"/>
            <a:ext cx="2667000" cy="17844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38"/>
          <p:cNvPicPr>
            <a:picLocks noChangeAspect="1" noChangeArrowheads="1"/>
          </p:cNvPicPr>
          <p:nvPr/>
        </p:nvPicPr>
        <p:blipFill>
          <a:blip r:embed="rId2" cstate="print"/>
          <a:srcRect l="26656" t="24110" r="57603" b="53513"/>
          <a:stretch>
            <a:fillRect/>
          </a:stretch>
        </p:blipFill>
        <p:spPr bwMode="auto">
          <a:xfrm>
            <a:off x="5715000" y="2590800"/>
            <a:ext cx="2590800" cy="17844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Rectangle 2"/>
          <p:cNvSpPr>
            <a:spLocks noChangeArrowheads="1"/>
          </p:cNvSpPr>
          <p:nvPr/>
        </p:nvSpPr>
        <p:spPr bwMode="auto">
          <a:xfrm>
            <a:off x="152400" y="4724400"/>
            <a:ext cx="8382000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ry Figure 3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. </a:t>
            </a: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Putative </a:t>
            </a:r>
            <a:r>
              <a:rPr kumimoji="0" lang="en-US" altLang="zh-CN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ubcellular</a:t>
            </a: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Localisations</a:t>
            </a: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of </a:t>
            </a:r>
            <a:r>
              <a:rPr kumimoji="0" lang="en-US" altLang="zh-CN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terpene</a:t>
            </a: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genes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from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Salvia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officinali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based </a:t>
            </a: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on Arabidopsis protein localization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at</a:t>
            </a:r>
            <a:r>
              <a:rPr lang="en-US" altLang="zh-CN" sz="1200" dirty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different </a:t>
            </a: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cell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organs. </a:t>
            </a: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Cell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ub-cellular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localisations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profile </a:t>
            </a: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images were built using Cell Electronic </a:t>
            </a:r>
            <a:r>
              <a:rPr lang="en-US" altLang="zh-CN" sz="1200" dirty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Fluorescent </a:t>
            </a: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Pictograph Browsers (Cell </a:t>
            </a:r>
            <a:r>
              <a:rPr kumimoji="0" lang="en-US" altLang="zh-CN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eFP</a:t>
            </a: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browsers. The blue arrow points the expression scale </a:t>
            </a:r>
            <a:r>
              <a:rPr lang="en-US" altLang="zh-CN" sz="1200" dirty="0"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(</a:t>
            </a: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the more intense red color, the more gene expression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),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hlinkClick r:id="rId3"/>
              </a:rPr>
              <a:t>http</a:t>
            </a:r>
            <a:r>
              <a:rPr kumimoji="0" lang="en-US" altLang="zh-CN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hlinkClick r:id="rId3"/>
              </a:rPr>
              <a:t>://bar.utoronto.ca/cell_efp/cgi-bin/cell_efp.cgi</a:t>
            </a: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endParaRPr kumimoji="0" lang="en-US" altLang="zh-CN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5</TotalTime>
  <Words>218</Words>
  <Application>Microsoft Office PowerPoint</Application>
  <PresentationFormat>On-screen Show (4:3)</PresentationFormat>
  <Paragraphs>3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ohammed Ali</dc:creator>
  <cp:lastModifiedBy>moham</cp:lastModifiedBy>
  <cp:revision>6</cp:revision>
  <dcterms:created xsi:type="dcterms:W3CDTF">2006-08-16T00:00:00Z</dcterms:created>
  <dcterms:modified xsi:type="dcterms:W3CDTF">2021-10-18T01:21:24Z</dcterms:modified>
</cp:coreProperties>
</file>